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08"/>
    <p:restoredTop sz="95100"/>
  </p:normalViewPr>
  <p:slideViewPr>
    <p:cSldViewPr snapToGrid="0" snapToObjects="1">
      <p:cViewPr varScale="1">
        <p:scale>
          <a:sx n="88" d="100"/>
          <a:sy n="88" d="100"/>
        </p:scale>
        <p:origin x="94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F5BAAC-BEBC-2741-9F48-F64A7912E92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05C9EE2-807C-DA45-AA64-9BB61A441E9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C39CA5-C308-7941-859F-C4BEE29466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6779A-147D-3043-848E-496B2B7CCAA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0FFBEB-70C2-0441-A115-3F2E4D0E4B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C3197C-C523-1647-9D07-91A08F74F2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0AE3C-82DC-7E48-9B7D-BC57F93B37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124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C1FE71-A60F-1345-BA16-DF0C654A59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E9038A-DE82-C041-A902-B6FD9FC622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F5C4C5-8881-1B48-97E6-29D3F8383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6779A-147D-3043-848E-496B2B7CCAA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4D8680-2809-9D45-A67A-9CDA00E4E9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3292D5-B45B-2E49-8A13-997DED4B18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0AE3C-82DC-7E48-9B7D-BC57F93B37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731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42B63CF-A106-7E41-A65B-B40039E7063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9DD9FA9-2EB0-E446-902E-230EBDAEE4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FDBD62-91E8-AE40-8A2C-5483F29A4A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6779A-147D-3043-848E-496B2B7CCAA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FEB1BB-3ACB-8F4F-8E9E-705E029A14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40FDF2-638F-1F40-9FEB-CD9AF6B697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0AE3C-82DC-7E48-9B7D-BC57F93B37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503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827D96-C443-4F4F-B27E-21EE06CF55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CA2927-09A4-5441-872F-A97F9D43FF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2E621C-23E9-3640-ABD9-29F1009E7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6779A-147D-3043-848E-496B2B7CCAA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B2FE3F-AB7F-EC4E-BD9E-44F0163BE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2CF6AA-5B26-6743-8349-81745FF556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0AE3C-82DC-7E48-9B7D-BC57F93B37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0119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98072B-4756-6148-B2FF-09B6F498DD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701B3A-D4B6-D842-BD86-3C67022165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FBA0B0-F96F-3F49-9DDF-BC116945E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6779A-147D-3043-848E-496B2B7CCAA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01BB7F-0510-2649-B25E-B94013A59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9E2D44-C74B-FD47-9621-93ACA3CCD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0AE3C-82DC-7E48-9B7D-BC57F93B37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937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CC3871-4FBD-4543-805F-23970BF9A3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CB9ED1-D3CF-4E4F-BCC0-881D2A3BCAB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B9208C-80D5-2542-8B67-6A6DA9EA16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9D99EC-16CB-7A48-B894-CFC64E69CC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6779A-147D-3043-848E-496B2B7CCAA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7408B3-985C-464E-80EB-9C9FBA09C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AEBA9A-6991-384A-A11F-4B7A8C8E0A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0AE3C-82DC-7E48-9B7D-BC57F93B37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3580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8AE696-C301-1049-8C64-F3496501B1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76570A-6B00-5642-B345-02C0B2FBFA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D7A05B-E281-9B40-B481-9E05AE2483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B7D586A-B56E-184B-968E-30A13E4AA0B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E17E999-165D-6549-8FF5-B56F2F7CA32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AC75886-AF49-D545-A533-09D89423E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6779A-147D-3043-848E-496B2B7CCAA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075222E-1BED-1947-8F08-297439F18E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0196D72-94C7-8642-8546-EBAA798DAA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0AE3C-82DC-7E48-9B7D-BC57F93B37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7882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F90D3B-251C-BF4E-AF34-01B2C77966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0C944C5-74AB-B843-B431-D3484D8D98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6779A-147D-3043-848E-496B2B7CCAA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90785DE-E4DF-524A-9E90-B900259506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86140E4-C15B-8F48-B7C0-D649CE4F2E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0AE3C-82DC-7E48-9B7D-BC57F93B37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1906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10D3571-12E7-0B45-9BDC-4C92AFF156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6779A-147D-3043-848E-496B2B7CCAA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36FA961-CD12-F84A-9C37-5B256AB41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77946AA-FFC1-7048-BC85-EA529BA47E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0AE3C-82DC-7E48-9B7D-BC57F93B37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9800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83882F-C5DC-D44C-8140-50BD1A416E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728530-27C7-D94A-A669-A902AF607B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AF7677-4161-C140-8509-AACA902B39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02E5E1-C761-264D-B6EC-741A11EBA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6779A-147D-3043-848E-496B2B7CCAA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7848A9C-4DF6-EC45-B9B6-8508734A48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C02811-A9D2-C844-806B-CED8F96F8A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0AE3C-82DC-7E48-9B7D-BC57F93B37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9049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13D366-25CE-2B4C-912F-8DE47B1E0B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7169874-4D28-CA48-9E51-99D9A932A0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D19ADC-6A73-5341-8609-E19A6D9C56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72886D-A190-0542-8C0E-BB2D5E6E7F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6779A-147D-3043-848E-496B2B7CCAA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3358C8-509E-2749-8889-35C9109979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627EF2-55BA-0242-9B50-1534EB028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0AE3C-82DC-7E48-9B7D-BC57F93B37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8353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EC7CD5E-3A99-0348-92D1-9CBB8A1588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9BACB6-D4F5-2F49-8155-A46D4A9B56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371BB1-D7BC-134F-A221-70C672DCA5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66779A-147D-3043-848E-496B2B7CCAA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6245DD-79A3-7844-8816-D56EB146C20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1E6943-E1EF-4944-9CA0-F421AA24213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80AE3C-82DC-7E48-9B7D-BC57F93B37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88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0EAADB8-AC3F-F24B-BB0C-B21215CCDF3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7117" t="-2972" r="-7389" b="-2813"/>
          <a:stretch/>
        </p:blipFill>
        <p:spPr>
          <a:xfrm>
            <a:off x="330141" y="4121191"/>
            <a:ext cx="3286517" cy="1652468"/>
          </a:xfrm>
          <a:prstGeom prst="rect">
            <a:avLst/>
          </a:prstGeom>
          <a:ln>
            <a:noFill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D435C82-0CBF-E640-A3F9-0F476DC1DA7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8995" t="-10537" r="-1767" b="-13950"/>
          <a:stretch/>
        </p:blipFill>
        <p:spPr>
          <a:xfrm>
            <a:off x="409434" y="2693332"/>
            <a:ext cx="3207224" cy="1596788"/>
          </a:xfrm>
          <a:prstGeom prst="rect">
            <a:avLst/>
          </a:prstGeom>
          <a:ln>
            <a:noFill/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5D8F8C6-D977-394F-930C-446F2625155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6478" t="-12957" r="-5563" b="-4729"/>
          <a:stretch/>
        </p:blipFill>
        <p:spPr>
          <a:xfrm>
            <a:off x="7325297" y="1922567"/>
            <a:ext cx="3201537" cy="1389971"/>
          </a:xfrm>
          <a:prstGeom prst="rect">
            <a:avLst/>
          </a:prstGeom>
          <a:ln>
            <a:noFill/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FCBA0BDD-6FCF-EB4F-8458-4B617E251EE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-3301" t="-16995" r="-6505" b="-11819"/>
          <a:stretch/>
        </p:blipFill>
        <p:spPr>
          <a:xfrm>
            <a:off x="556018" y="5548908"/>
            <a:ext cx="3123819" cy="1372432"/>
          </a:xfrm>
          <a:prstGeom prst="rect">
            <a:avLst/>
          </a:prstGeom>
          <a:ln>
            <a:noFill/>
          </a:ln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BC66391A-08AE-814C-B839-A5E7A42680C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-5723" t="-4665" r="-5563" b="-15507"/>
          <a:stretch/>
        </p:blipFill>
        <p:spPr>
          <a:xfrm>
            <a:off x="436730" y="99743"/>
            <a:ext cx="3179928" cy="1419366"/>
          </a:xfrm>
          <a:prstGeom prst="rect">
            <a:avLst/>
          </a:prstGeom>
          <a:ln>
            <a:noFill/>
          </a:ln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F39768DE-E9A3-9349-A9F8-3C4A2CB567B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-6264" t="-13806" r="-4157" b="-2482"/>
          <a:stretch/>
        </p:blipFill>
        <p:spPr>
          <a:xfrm>
            <a:off x="7582953" y="4574904"/>
            <a:ext cx="3155265" cy="1373420"/>
          </a:xfrm>
          <a:prstGeom prst="rect">
            <a:avLst/>
          </a:prstGeom>
          <a:ln>
            <a:noFill/>
          </a:ln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013B2EFE-0E6D-1846-9636-40C0FAC27F5C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-5479" t="-2693" r="-6302" b="-8803"/>
          <a:stretch/>
        </p:blipFill>
        <p:spPr>
          <a:xfrm>
            <a:off x="573207" y="1692322"/>
            <a:ext cx="3179928" cy="1132765"/>
          </a:xfrm>
          <a:prstGeom prst="rect">
            <a:avLst/>
          </a:prstGeom>
          <a:ln>
            <a:noFill/>
          </a:ln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129EC946-CDAE-A942-8521-3FE9C428941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0148" t="-6666" r="-1280" b="-8096"/>
          <a:stretch/>
        </p:blipFill>
        <p:spPr>
          <a:xfrm>
            <a:off x="7188820" y="3199440"/>
            <a:ext cx="3226560" cy="1472010"/>
          </a:xfrm>
          <a:prstGeom prst="rect">
            <a:avLst/>
          </a:prstGeom>
          <a:ln>
            <a:noFill/>
          </a:ln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868B013E-744A-AA4B-B72A-F6ECD9249A9A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-6245" t="-6493" r="-1773" b="-1119"/>
          <a:stretch/>
        </p:blipFill>
        <p:spPr>
          <a:xfrm>
            <a:off x="7255765" y="300251"/>
            <a:ext cx="3100316" cy="1680951"/>
          </a:xfrm>
          <a:prstGeom prst="rect">
            <a:avLst/>
          </a:prstGeom>
          <a:ln>
            <a:noFill/>
          </a:ln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C84938DD-1B91-C940-8ECB-8A56BF48AAEB}"/>
              </a:ext>
            </a:extLst>
          </p:cNvPr>
          <p:cNvSpPr txBox="1"/>
          <p:nvPr/>
        </p:nvSpPr>
        <p:spPr>
          <a:xfrm>
            <a:off x="3358902" y="4673280"/>
            <a:ext cx="8114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ufs1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9AC5C75-A9A8-2144-95D4-08AC8683051B}"/>
              </a:ext>
            </a:extLst>
          </p:cNvPr>
          <p:cNvSpPr txBox="1"/>
          <p:nvPr/>
        </p:nvSpPr>
        <p:spPr>
          <a:xfrm>
            <a:off x="3382051" y="885082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ns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208842A-55C8-4646-8D55-E6ACE6E11689}"/>
              </a:ext>
            </a:extLst>
          </p:cNvPr>
          <p:cNvSpPr txBox="1"/>
          <p:nvPr/>
        </p:nvSpPr>
        <p:spPr>
          <a:xfrm>
            <a:off x="3616658" y="1922567"/>
            <a:ext cx="6639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at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311AC02-FAE1-3E48-BF8D-56A57D864E4F}"/>
              </a:ext>
            </a:extLst>
          </p:cNvPr>
          <p:cNvSpPr txBox="1"/>
          <p:nvPr/>
        </p:nvSpPr>
        <p:spPr>
          <a:xfrm>
            <a:off x="3478059" y="3462408"/>
            <a:ext cx="6174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ph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C20BEDF5-4F30-1B41-88B8-E7807A866F3B}"/>
              </a:ext>
            </a:extLst>
          </p:cNvPr>
          <p:cNvSpPr txBox="1"/>
          <p:nvPr/>
        </p:nvSpPr>
        <p:spPr>
          <a:xfrm>
            <a:off x="3541377" y="6144781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6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3DF1032-23BB-8844-A846-9191495D420D}"/>
              </a:ext>
            </a:extLst>
          </p:cNvPr>
          <p:cNvSpPr txBox="1"/>
          <p:nvPr/>
        </p:nvSpPr>
        <p:spPr>
          <a:xfrm>
            <a:off x="10265975" y="775899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A378220-FB22-AB41-ADB2-BBCC56E43193}"/>
              </a:ext>
            </a:extLst>
          </p:cNvPr>
          <p:cNvSpPr txBox="1"/>
          <p:nvPr/>
        </p:nvSpPr>
        <p:spPr>
          <a:xfrm>
            <a:off x="10439260" y="2416333"/>
            <a:ext cx="8675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4Ebp1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6171ABE-4792-AA43-922A-691D92A3A7D6}"/>
              </a:ext>
            </a:extLst>
          </p:cNvPr>
          <p:cNvSpPr txBox="1"/>
          <p:nvPr/>
        </p:nvSpPr>
        <p:spPr>
          <a:xfrm>
            <a:off x="10272336" y="1162081"/>
            <a:ext cx="7537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Ebp1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DC60B522-5F4F-CA4C-B897-E8B883AB602F}"/>
              </a:ext>
            </a:extLst>
          </p:cNvPr>
          <p:cNvSpPr txBox="1"/>
          <p:nvPr/>
        </p:nvSpPr>
        <p:spPr>
          <a:xfrm>
            <a:off x="10403385" y="3495618"/>
            <a:ext cx="7777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rd7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3FE9FB1-C0E9-224D-81F5-64C4085153E2}"/>
              </a:ext>
            </a:extLst>
          </p:cNvPr>
          <p:cNvSpPr txBox="1"/>
          <p:nvPr/>
        </p:nvSpPr>
        <p:spPr>
          <a:xfrm>
            <a:off x="10548855" y="5261614"/>
            <a:ext cx="7441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90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B7E662D9-2BED-D04B-94AA-2B34112693E1}"/>
              </a:ext>
            </a:extLst>
          </p:cNvPr>
          <p:cNvSpPr/>
          <p:nvPr/>
        </p:nvSpPr>
        <p:spPr>
          <a:xfrm>
            <a:off x="777922" y="914400"/>
            <a:ext cx="2074460" cy="21836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468C3FAC-514B-FE4C-8DAF-4E420EC00D6A}"/>
              </a:ext>
            </a:extLst>
          </p:cNvPr>
          <p:cNvSpPr/>
          <p:nvPr/>
        </p:nvSpPr>
        <p:spPr>
          <a:xfrm>
            <a:off x="971266" y="1981202"/>
            <a:ext cx="2074460" cy="21836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F9341668-1E5A-5F47-8D7E-CD97A6314037}"/>
              </a:ext>
            </a:extLst>
          </p:cNvPr>
          <p:cNvSpPr/>
          <p:nvPr/>
        </p:nvSpPr>
        <p:spPr>
          <a:xfrm>
            <a:off x="777922" y="3491726"/>
            <a:ext cx="2074460" cy="21836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F2B61311-E3EC-834F-8964-D557FB19E3EE}"/>
              </a:ext>
            </a:extLst>
          </p:cNvPr>
          <p:cNvSpPr/>
          <p:nvPr/>
        </p:nvSpPr>
        <p:spPr>
          <a:xfrm>
            <a:off x="7768693" y="805217"/>
            <a:ext cx="2074460" cy="21836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3242AF5D-B07A-274E-9950-4018EC1936D6}"/>
              </a:ext>
            </a:extLst>
          </p:cNvPr>
          <p:cNvSpPr/>
          <p:nvPr/>
        </p:nvSpPr>
        <p:spPr>
          <a:xfrm>
            <a:off x="777922" y="6203620"/>
            <a:ext cx="2074460" cy="21836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A232E96B-59B3-8F46-9B33-4CA4FF96AB1C}"/>
              </a:ext>
            </a:extLst>
          </p:cNvPr>
          <p:cNvSpPr/>
          <p:nvPr/>
        </p:nvSpPr>
        <p:spPr>
          <a:xfrm>
            <a:off x="7768693" y="2421720"/>
            <a:ext cx="2074460" cy="21836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990B9EDE-89DC-C643-B8B4-B5C476D95CB1}"/>
              </a:ext>
            </a:extLst>
          </p:cNvPr>
          <p:cNvSpPr/>
          <p:nvPr/>
        </p:nvSpPr>
        <p:spPr>
          <a:xfrm>
            <a:off x="7798261" y="1189377"/>
            <a:ext cx="2074460" cy="31415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Rectangle 106">
            <a:extLst>
              <a:ext uri="{FF2B5EF4-FFF2-40B4-BE49-F238E27FC236}">
                <a16:creationId xmlns:a16="http://schemas.microsoft.com/office/drawing/2014/main" id="{5D258CBE-343A-A549-A972-F91BBA2A17C5}"/>
              </a:ext>
            </a:extLst>
          </p:cNvPr>
          <p:cNvSpPr/>
          <p:nvPr/>
        </p:nvSpPr>
        <p:spPr>
          <a:xfrm>
            <a:off x="7600372" y="3522155"/>
            <a:ext cx="2074460" cy="21836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id="{1F2B7EF8-94B6-A040-971C-9D1A9BBD100B}"/>
              </a:ext>
            </a:extLst>
          </p:cNvPr>
          <p:cNvSpPr/>
          <p:nvPr/>
        </p:nvSpPr>
        <p:spPr>
          <a:xfrm>
            <a:off x="8009338" y="5290931"/>
            <a:ext cx="2074460" cy="21836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CDD27B1-FA67-A24C-B45F-25C1517601D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rot="5400000" flipV="1">
            <a:off x="8290497" y="5157154"/>
            <a:ext cx="457200" cy="2387600"/>
          </a:xfrm>
          <a:prstGeom prst="rect">
            <a:avLst/>
          </a:prstGeom>
        </p:spPr>
      </p:pic>
      <p:sp>
        <p:nvSpPr>
          <p:cNvPr id="109" name="TextBox 108">
            <a:extLst>
              <a:ext uri="{FF2B5EF4-FFF2-40B4-BE49-F238E27FC236}">
                <a16:creationId xmlns:a16="http://schemas.microsoft.com/office/drawing/2014/main" id="{9538BE7B-17A0-E541-B3EF-755FA26D9987}"/>
              </a:ext>
            </a:extLst>
          </p:cNvPr>
          <p:cNvSpPr txBox="1"/>
          <p:nvPr/>
        </p:nvSpPr>
        <p:spPr>
          <a:xfrm>
            <a:off x="9872722" y="6027003"/>
            <a:ext cx="223439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90 (second membrane, not shown in Expanded View Figure 8)</a:t>
            </a:r>
          </a:p>
        </p:txBody>
      </p:sp>
      <p:sp>
        <p:nvSpPr>
          <p:cNvPr id="32" name="ZoneTexte 5">
            <a:extLst>
              <a:ext uri="{FF2B5EF4-FFF2-40B4-BE49-F238E27FC236}">
                <a16:creationId xmlns:a16="http://schemas.microsoft.com/office/drawing/2014/main" id="{B267F51C-CFD6-A242-AB15-56D3DDD74424}"/>
              </a:ext>
            </a:extLst>
          </p:cNvPr>
          <p:cNvSpPr txBox="1"/>
          <p:nvPr/>
        </p:nvSpPr>
        <p:spPr>
          <a:xfrm>
            <a:off x="4578105" y="289314"/>
            <a:ext cx="2610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anded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ew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8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B7E662D9-2BED-D04B-94AA-2B34112693E1}"/>
              </a:ext>
            </a:extLst>
          </p:cNvPr>
          <p:cNvSpPr/>
          <p:nvPr/>
        </p:nvSpPr>
        <p:spPr>
          <a:xfrm>
            <a:off x="889455" y="4687099"/>
            <a:ext cx="2074460" cy="39529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3863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Macintosh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crosoft Office User</dc:creator>
  <cp:keywords/>
  <dc:description/>
  <cp:lastModifiedBy>Microsoft Office User</cp:lastModifiedBy>
  <cp:revision>1</cp:revision>
  <dcterms:created xsi:type="dcterms:W3CDTF">2025-12-05T15:09:28Z</dcterms:created>
  <dcterms:modified xsi:type="dcterms:W3CDTF">2025-12-05T15:09:43Z</dcterms:modified>
  <cp:category/>
</cp:coreProperties>
</file>